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88" r:id="rId2"/>
    <p:sldId id="287" r:id="rId3"/>
    <p:sldId id="292" r:id="rId4"/>
    <p:sldId id="289" r:id="rId5"/>
    <p:sldId id="291" r:id="rId6"/>
    <p:sldId id="256" r:id="rId7"/>
    <p:sldId id="293" r:id="rId8"/>
    <p:sldId id="294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1250" autoAdjust="0"/>
  </p:normalViewPr>
  <p:slideViewPr>
    <p:cSldViewPr snapToGrid="0">
      <p:cViewPr varScale="1">
        <p:scale>
          <a:sx n="55" d="100"/>
          <a:sy n="55" d="100"/>
        </p:scale>
        <p:origin x="1072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image" Target="../media/image6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image" Target="../media/image8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8BE89F3-B0F3-403E-BDB0-64D424A49E47}" type="datetimeFigureOut">
              <a:rPr lang="en-GB" smtClean="0"/>
              <a:t>22/10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F904EDE-00D9-4A56-80E0-C1A0EE2B5C1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49005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F904EDE-00D9-4A56-80E0-C1A0EE2B5C10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796025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F904EDE-00D9-4A56-80E0-C1A0EE2B5C10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367550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F904EDE-00D9-4A56-80E0-C1A0EE2B5C10}" type="slidenum">
              <a:rPr lang="en-GB" smtClean="0"/>
              <a:t>7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56168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516381-791C-4E36-86E5-9868F73FFB2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FF6154E-1F94-429A-BDC0-243E2E22EAB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26F017-0628-4EBA-AF61-E273507F9E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AA38F-E307-4206-9248-230016508B46}" type="datetimeFigureOut">
              <a:rPr lang="en-GB" smtClean="0"/>
              <a:t>22/10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F4BF8E-691D-4F9D-B6AC-A1291A5291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316755-A85E-408D-836C-8465C08863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CDA348-749A-4205-A5E2-591CA428D0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73009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C563F7-8410-4BC2-9325-DF675E3556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B76FF39-37EA-430B-A2A8-43C59A2CC40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4B6519-7A14-4408-A17D-3B3641681B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AA38F-E307-4206-9248-230016508B46}" type="datetimeFigureOut">
              <a:rPr lang="en-GB" smtClean="0"/>
              <a:t>22/10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BD0275-59C5-42D4-9DC3-922BA1201D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25E3C9-8EEA-44F7-8D37-8076D449C2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CDA348-749A-4205-A5E2-591CA428D0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64539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B36D73C-3DD7-41E7-A558-DCBAACB0C4D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53840CB-504D-4914-8F71-26B21F0362D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24AA23-43D1-4BF8-AB76-4AE3388D50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AA38F-E307-4206-9248-230016508B46}" type="datetimeFigureOut">
              <a:rPr lang="en-GB" smtClean="0"/>
              <a:t>22/10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487200-B624-4911-8E0F-E79024AB8A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6C2AC2-5331-4227-ADEE-DD47B3932D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CDA348-749A-4205-A5E2-591CA428D0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94918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92D39B-D86E-476F-8211-5F2AAFAC0A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90CB0BB-2274-499C-BB29-D74412E2549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5C69AE-ABB6-4293-8C30-9AFFF60B59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AA38F-E307-4206-9248-230016508B46}" type="datetimeFigureOut">
              <a:rPr lang="en-GB" smtClean="0"/>
              <a:t>22/10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2DDF76-A5B5-4204-837A-D541358E63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4712E9-B183-49C6-822A-48D09F2B07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CDA348-749A-4205-A5E2-591CA428D0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88973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C5DFAD-32B2-461F-8855-54AC6684D4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6E08335-090F-41F6-8220-FC9033E4E8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1A8C45-C85A-45BF-9A91-B255A8C10F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AA38F-E307-4206-9248-230016508B46}" type="datetimeFigureOut">
              <a:rPr lang="en-GB" smtClean="0"/>
              <a:t>22/10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E99EB2-8D1B-47E8-8F08-630EFD48FD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9D06DC-812F-4B6A-8F7D-8126847208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CDA348-749A-4205-A5E2-591CA428D0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627452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B46812-FCF2-44EF-8CF2-3DF3061075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FF2DE0-8DF0-4627-9FCC-B8A3D6012F5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D7BC7D3-FB63-4C32-AA44-B58EA4D8901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C6B913C-1BEF-496E-9C5A-17F4FA9CDD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AA38F-E307-4206-9248-230016508B46}" type="datetimeFigureOut">
              <a:rPr lang="en-GB" smtClean="0"/>
              <a:t>22/10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AF5856-369C-4280-B8F6-6CD8802181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05900C1-55AC-46BC-A5DC-872AA55F29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CDA348-749A-4205-A5E2-591CA428D0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76742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93758E-EA85-44AC-83AC-5ABA3DBBF8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6A4B89B-6E58-4979-9BF0-D115773893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8AE806A-F44C-48E6-9B95-777E8649B40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90AAAA6-941A-40ED-8AF4-6E57909BE6A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710148A-4EF4-4249-AB59-196CAB7DB7D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2586263-CBC2-4F09-BF46-A0D28DBB25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AA38F-E307-4206-9248-230016508B46}" type="datetimeFigureOut">
              <a:rPr lang="en-GB" smtClean="0"/>
              <a:t>22/10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47ACE84-3BC5-4832-A677-4B2B5A64CA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9D1A282-3E0E-48F8-8354-BF612D04E2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CDA348-749A-4205-A5E2-591CA428D0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96664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1E8481-DB63-41F2-A118-31FE58DD28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350BDCE-7002-4FFF-8ED1-E553A7B34F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AA38F-E307-4206-9248-230016508B46}" type="datetimeFigureOut">
              <a:rPr lang="en-GB" smtClean="0"/>
              <a:t>22/10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E6DE73C-06E2-43EC-86DD-C1D7A0A15D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5C05519-63B7-4767-92E4-0C9E294B36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CDA348-749A-4205-A5E2-591CA428D0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83661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E55DF34-6461-459B-A61F-27CBAA3A53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AA38F-E307-4206-9248-230016508B46}" type="datetimeFigureOut">
              <a:rPr lang="en-GB" smtClean="0"/>
              <a:t>22/10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03F7376-0407-4F17-ACE0-CDCBBEA5BC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729CAA0-F797-43B2-B1A8-66E0457F0F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CDA348-749A-4205-A5E2-591CA428D0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23777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31B198-1BB4-412B-8A80-DC88057C82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B462DEC-C94D-4E2C-8FCB-688C70A1066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786E089-0A96-4FD5-AE41-92DFAE61DC3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EA1A893-343C-4F03-A152-C13B6E6598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AA38F-E307-4206-9248-230016508B46}" type="datetimeFigureOut">
              <a:rPr lang="en-GB" smtClean="0"/>
              <a:t>22/10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7A7E816-E88F-4479-90EB-E55B625844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DAD0E42-58AB-4F22-95D2-D020015D5F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CDA348-749A-4205-A5E2-591CA428D0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17680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1FA36D-E65D-48F6-8EB3-3A36C70099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01112BF-7A3F-4F74-B68B-6B8A858B1C0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5DD642A-9894-4B0E-A818-082944FDA8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FE6738B-CCF1-4A8A-9D02-03196AB48D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AA38F-E307-4206-9248-230016508B46}" type="datetimeFigureOut">
              <a:rPr lang="en-GB" smtClean="0"/>
              <a:t>22/10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3A4CB8E-9C29-449C-9AEF-3F874A3AFB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F3C1916-2568-4D91-B77A-F67D631F3F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CDA348-749A-4205-A5E2-591CA428D0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75858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0B8C701-9C16-4FB9-8E7F-5F59F792BB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58656FA-6DD3-42FE-B9C9-6678EA673D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CBEC4C-13D7-416E-A45D-FE30B0AA6F6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6AA38F-E307-4206-9248-230016508B46}" type="datetimeFigureOut">
              <a:rPr lang="en-GB" smtClean="0"/>
              <a:t>22/10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79266F-B0BE-4DB8-87A3-901E8E63822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DD5BC5-130B-4833-BE43-081F4EEDF7E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CDA348-749A-4205-A5E2-591CA428D0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73962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7" Type="http://schemas.openxmlformats.org/officeDocument/2006/relationships/image" Target="../media/image7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6.emf"/><Relationship Id="rId4" Type="http://schemas.openxmlformats.org/officeDocument/2006/relationships/oleObject" Target="../embeddings/oleObject1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9.emf"/><Relationship Id="rId5" Type="http://schemas.openxmlformats.org/officeDocument/2006/relationships/oleObject" Target="../embeddings/oleObject4.bin"/><Relationship Id="rId4" Type="http://schemas.openxmlformats.org/officeDocument/2006/relationships/image" Target="../media/image8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1F6D2263-C59A-530B-61D4-D52495206C6E}"/>
              </a:ext>
            </a:extLst>
          </p:cNvPr>
          <p:cNvGrpSpPr/>
          <p:nvPr/>
        </p:nvGrpSpPr>
        <p:grpSpPr>
          <a:xfrm>
            <a:off x="742585" y="132204"/>
            <a:ext cx="10249622" cy="2499192"/>
            <a:chOff x="1160500" y="575637"/>
            <a:chExt cx="10249622" cy="2499192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2232C461-F4BB-4E2C-85E0-7487B21389E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b="15284"/>
            <a:stretch/>
          </p:blipFill>
          <p:spPr>
            <a:xfrm>
              <a:off x="1160500" y="925469"/>
              <a:ext cx="2156360" cy="2024466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A8B443A3-A313-4EC2-BC64-1FF669728E7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b="15284"/>
            <a:stretch/>
          </p:blipFill>
          <p:spPr>
            <a:xfrm>
              <a:off x="4057339" y="919838"/>
              <a:ext cx="2156360" cy="2024467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9B871EA3-F5BA-46AA-8DE3-407A831C312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497823" y="789313"/>
              <a:ext cx="2300060" cy="2285516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466DCD82-03A9-40EF-BEC8-DC4D4527045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b="27771"/>
            <a:stretch/>
          </p:blipFill>
          <p:spPr>
            <a:xfrm>
              <a:off x="9050670" y="896042"/>
              <a:ext cx="2359452" cy="2178787"/>
            </a:xfrm>
            <a:prstGeom prst="rect">
              <a:avLst/>
            </a:prstGeom>
          </p:spPr>
        </p:pic>
        <p:sp>
          <p:nvSpPr>
            <p:cNvPr id="9" name="TextBox 1">
              <a:extLst>
                <a:ext uri="{FF2B5EF4-FFF2-40B4-BE49-F238E27FC236}">
                  <a16:creationId xmlns:a16="http://schemas.microsoft.com/office/drawing/2014/main" id="{D46CB022-E4D1-406E-9857-44BA9C378430}"/>
                </a:ext>
              </a:extLst>
            </p:cNvPr>
            <p:cNvSpPr txBox="1"/>
            <p:nvPr/>
          </p:nvSpPr>
          <p:spPr>
            <a:xfrm>
              <a:off x="1284772" y="627603"/>
              <a:ext cx="677269" cy="44741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GB" sz="14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</a:t>
              </a:r>
              <a:endParaRPr lang="en-GB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14">
              <a:extLst>
                <a:ext uri="{FF2B5EF4-FFF2-40B4-BE49-F238E27FC236}">
                  <a16:creationId xmlns:a16="http://schemas.microsoft.com/office/drawing/2014/main" id="{A8E21F52-A669-4111-A125-A66B5BE2EB45}"/>
                </a:ext>
              </a:extLst>
            </p:cNvPr>
            <p:cNvSpPr txBox="1"/>
            <p:nvPr/>
          </p:nvSpPr>
          <p:spPr>
            <a:xfrm>
              <a:off x="4152399" y="627603"/>
              <a:ext cx="677269" cy="44741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GB" sz="14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B</a:t>
              </a:r>
              <a:endParaRPr lang="en-GB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5">
              <a:extLst>
                <a:ext uri="{FF2B5EF4-FFF2-40B4-BE49-F238E27FC236}">
                  <a16:creationId xmlns:a16="http://schemas.microsoft.com/office/drawing/2014/main" id="{23BE9F7D-1419-434A-AC7B-5ECCD9CE0EFE}"/>
                </a:ext>
              </a:extLst>
            </p:cNvPr>
            <p:cNvSpPr txBox="1"/>
            <p:nvPr/>
          </p:nvSpPr>
          <p:spPr>
            <a:xfrm>
              <a:off x="6470229" y="601620"/>
              <a:ext cx="677269" cy="44741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GB" sz="14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</a:t>
              </a:r>
              <a:endParaRPr lang="en-GB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16">
              <a:extLst>
                <a:ext uri="{FF2B5EF4-FFF2-40B4-BE49-F238E27FC236}">
                  <a16:creationId xmlns:a16="http://schemas.microsoft.com/office/drawing/2014/main" id="{7673C2ED-C52E-4C96-B4AD-DDA7258F253B}"/>
                </a:ext>
              </a:extLst>
            </p:cNvPr>
            <p:cNvSpPr txBox="1"/>
            <p:nvPr/>
          </p:nvSpPr>
          <p:spPr>
            <a:xfrm>
              <a:off x="9131671" y="575637"/>
              <a:ext cx="677269" cy="44741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GB" sz="1400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D</a:t>
              </a:r>
              <a:endParaRPr lang="en-GB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3" name="Rectangle 12">
            <a:extLst>
              <a:ext uri="{FF2B5EF4-FFF2-40B4-BE49-F238E27FC236}">
                <a16:creationId xmlns:a16="http://schemas.microsoft.com/office/drawing/2014/main" id="{39862EC0-365B-4EE1-9582-6B3FE893578F}"/>
              </a:ext>
            </a:extLst>
          </p:cNvPr>
          <p:cNvSpPr/>
          <p:nvPr/>
        </p:nvSpPr>
        <p:spPr>
          <a:xfrm>
            <a:off x="3734484" y="3453788"/>
            <a:ext cx="7910345" cy="25853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i="1" dirty="0"/>
              <a:t>Supplementary Figure 1: The gating strategy implemented to identify NK cell populations within each blood and tissue sample following flow cytometry.</a:t>
            </a:r>
          </a:p>
          <a:p>
            <a:r>
              <a:rPr lang="en-GB" dirty="0"/>
              <a:t>Analysis of flow cytometric data allowed the detection of: A) single cells, B) lymphocytes, C) live cells with CD45 expression, and D) the NK cell population. The NK cell population was separated into four subtypes E): </a:t>
            </a:r>
            <a:r>
              <a:rPr lang="en-GB" dirty="0">
                <a:ea typeface="Calibri" panose="020F0502020204030204" pitchFamily="34" charset="0"/>
                <a:cs typeface="Times New Roman" panose="02020603050405020304" pitchFamily="18" charset="0"/>
              </a:rPr>
              <a:t>low CD16 and low CD56 expression (B--), low CD16 and high CD56 expression (B-+), high CD16 and high CD56 expression (B++), and high CD16 and low CD56 expression (B+-).  </a:t>
            </a:r>
          </a:p>
          <a:p>
            <a:endParaRPr lang="en-GB" dirty="0"/>
          </a:p>
          <a:p>
            <a:endParaRPr lang="en-GB" dirty="0"/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262D40BF-A14F-4947-96EB-73E5C6D8892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42584" y="2991654"/>
            <a:ext cx="2156359" cy="2910344"/>
          </a:xfrm>
          <a:prstGeom prst="rect">
            <a:avLst/>
          </a:prstGeom>
        </p:spPr>
      </p:pic>
      <p:sp>
        <p:nvSpPr>
          <p:cNvPr id="22" name="TextBox 16">
            <a:extLst>
              <a:ext uri="{FF2B5EF4-FFF2-40B4-BE49-F238E27FC236}">
                <a16:creationId xmlns:a16="http://schemas.microsoft.com/office/drawing/2014/main" id="{D1193F28-A491-4326-8471-A364CCCBFE65}"/>
              </a:ext>
            </a:extLst>
          </p:cNvPr>
          <p:cNvSpPr txBox="1"/>
          <p:nvPr/>
        </p:nvSpPr>
        <p:spPr>
          <a:xfrm>
            <a:off x="861158" y="2580660"/>
            <a:ext cx="677269" cy="44741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endParaRPr lang="en-GB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654953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>
            <a:extLst>
              <a:ext uri="{FF2B5EF4-FFF2-40B4-BE49-F238E27FC236}">
                <a16:creationId xmlns:a16="http://schemas.microsoft.com/office/drawing/2014/main" id="{AA418D55-9549-479A-98B4-BEEA7098CDD8}"/>
              </a:ext>
            </a:extLst>
          </p:cNvPr>
          <p:cNvGrpSpPr/>
          <p:nvPr/>
        </p:nvGrpSpPr>
        <p:grpSpPr>
          <a:xfrm>
            <a:off x="2692530" y="1138466"/>
            <a:ext cx="7217014" cy="3095629"/>
            <a:chOff x="4243742" y="3724779"/>
            <a:chExt cx="3295870" cy="1145797"/>
          </a:xfrm>
        </p:grpSpPr>
        <p:graphicFrame>
          <p:nvGraphicFramePr>
            <p:cNvPr id="6" name="Object 5">
              <a:extLst>
                <a:ext uri="{FF2B5EF4-FFF2-40B4-BE49-F238E27FC236}">
                  <a16:creationId xmlns:a16="http://schemas.microsoft.com/office/drawing/2014/main" id="{FBBB6003-1F0D-42C3-8209-E725EC56F8D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491064399"/>
                </p:ext>
              </p:extLst>
            </p:nvPr>
          </p:nvGraphicFramePr>
          <p:xfrm>
            <a:off x="4243742" y="3724792"/>
            <a:ext cx="1505637" cy="114578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54" name="Prism 9" r:id="rId4" imgW="4833021" imgH="3834862" progId="Prism9.Document">
                    <p:embed/>
                  </p:oleObj>
                </mc:Choice>
                <mc:Fallback>
                  <p:oleObj name="Prism 9" r:id="rId4" imgW="4833021" imgH="3834862" progId="Prism9.Document">
                    <p:embed/>
                    <p:pic>
                      <p:nvPicPr>
                        <p:cNvPr id="6" name="Object 5">
                          <a:extLst>
                            <a:ext uri="{FF2B5EF4-FFF2-40B4-BE49-F238E27FC236}">
                              <a16:creationId xmlns:a16="http://schemas.microsoft.com/office/drawing/2014/main" id="{FBBB6003-1F0D-42C3-8209-E725EC56F8D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4243742" y="3724792"/>
                          <a:ext cx="1505637" cy="114578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Object 6">
              <a:extLst>
                <a:ext uri="{FF2B5EF4-FFF2-40B4-BE49-F238E27FC236}">
                  <a16:creationId xmlns:a16="http://schemas.microsoft.com/office/drawing/2014/main" id="{9047388A-21DB-4616-8756-8320F12B1F8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10510666"/>
                </p:ext>
              </p:extLst>
            </p:nvPr>
          </p:nvGraphicFramePr>
          <p:xfrm>
            <a:off x="6033975" y="3724779"/>
            <a:ext cx="1505637" cy="114579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55" name="Prism 9" r:id="rId6" imgW="4833021" imgH="3478055" progId="Prism9.Document">
                    <p:embed/>
                  </p:oleObj>
                </mc:Choice>
                <mc:Fallback>
                  <p:oleObj name="Prism 9" r:id="rId6" imgW="4833021" imgH="3478055" progId="Prism9.Document">
                    <p:embed/>
                    <p:pic>
                      <p:nvPicPr>
                        <p:cNvPr id="7" name="Object 6">
                          <a:extLst>
                            <a:ext uri="{FF2B5EF4-FFF2-40B4-BE49-F238E27FC236}">
                              <a16:creationId xmlns:a16="http://schemas.microsoft.com/office/drawing/2014/main" id="{9047388A-21DB-4616-8756-8320F12B1F8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6033975" y="3724779"/>
                          <a:ext cx="1505637" cy="114579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10" name="Rectangle 9">
            <a:extLst>
              <a:ext uri="{FF2B5EF4-FFF2-40B4-BE49-F238E27FC236}">
                <a16:creationId xmlns:a16="http://schemas.microsoft.com/office/drawing/2014/main" id="{05D8CD20-78F5-D758-0A41-52FC491CF0AE}"/>
              </a:ext>
            </a:extLst>
          </p:cNvPr>
          <p:cNvSpPr/>
          <p:nvPr/>
        </p:nvSpPr>
        <p:spPr>
          <a:xfrm>
            <a:off x="823025" y="4404216"/>
            <a:ext cx="11133723" cy="169277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b="1" i="1" dirty="0"/>
              <a:t>Supplementary Figure 2: The proportion of peripheral NK cells based on CD56 expression. </a:t>
            </a: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sz="18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There was a greater proportion of the CD56</a:t>
            </a:r>
            <a:r>
              <a:rPr lang="en-GB" sz="1800" baseline="30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bri </a:t>
            </a:r>
            <a:r>
              <a:rPr lang="en-GB" sz="18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NK cell subset in OC patients than in the healthy donors (p = 0.0282), while ther</a:t>
            </a:r>
            <a:r>
              <a:rPr lang="en-GB" dirty="0">
                <a:ea typeface="Calibri" panose="020F0502020204030204" pitchFamily="34" charset="0"/>
                <a:cs typeface="Times New Roman" panose="02020603050405020304" pitchFamily="18" charset="0"/>
              </a:rPr>
              <a:t>e was </a:t>
            </a:r>
            <a:r>
              <a:rPr lang="en-GB" sz="18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no difference in the CD56</a:t>
            </a:r>
            <a:r>
              <a:rPr lang="en-GB" sz="1800" baseline="30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dim</a:t>
            </a:r>
            <a:r>
              <a:rPr lang="en-GB" baseline="30000" dirty="0"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8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NK cell subset between the tw</a:t>
            </a:r>
            <a:r>
              <a:rPr lang="en-GB" dirty="0">
                <a:ea typeface="Calibri" panose="020F0502020204030204" pitchFamily="34" charset="0"/>
                <a:cs typeface="Times New Roman" panose="02020603050405020304" pitchFamily="18" charset="0"/>
              </a:rPr>
              <a:t>o cohorts</a:t>
            </a:r>
            <a:r>
              <a:rPr lang="en-GB" sz="18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endParaRPr lang="en-GB" altLang="en-US" sz="3200" dirty="0"/>
          </a:p>
          <a:p>
            <a:r>
              <a:rPr lang="en-GB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1174527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D91EEBFD-DCB1-4EB8-BB37-D35169EC13B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41679104"/>
              </p:ext>
            </p:extLst>
          </p:nvPr>
        </p:nvGraphicFramePr>
        <p:xfrm>
          <a:off x="6541641" y="1531821"/>
          <a:ext cx="3650033" cy="275745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8" name="Prism 9" r:id="rId3" imgW="4797728" imgH="3624595" progId="Prism9.Document">
                  <p:embed/>
                </p:oleObj>
              </mc:Choice>
              <mc:Fallback>
                <p:oleObj name="Prism 9" r:id="rId3" imgW="4797728" imgH="3624595" progId="Prism9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2B69E105-381E-4AE8-8732-07DF0D24F13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541641" y="1531821"/>
                        <a:ext cx="3650033" cy="275745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1E80F666-F983-4533-B928-0FB868990F9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75274551"/>
              </p:ext>
            </p:extLst>
          </p:nvPr>
        </p:nvGraphicFramePr>
        <p:xfrm>
          <a:off x="1582028" y="1531821"/>
          <a:ext cx="3648825" cy="275745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9" name="Prism 9" r:id="rId5" imgW="4796287" imgH="3624595" progId="Prism9.Document">
                  <p:embed/>
                </p:oleObj>
              </mc:Choice>
              <mc:Fallback>
                <p:oleObj name="Prism 9" r:id="rId5" imgW="4796287" imgH="3624595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CF6832A4-C097-467F-BDCE-13B72C0FA56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582028" y="1531821"/>
                        <a:ext cx="3648825" cy="275745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Rectangle 3">
            <a:extLst>
              <a:ext uri="{FF2B5EF4-FFF2-40B4-BE49-F238E27FC236}">
                <a16:creationId xmlns:a16="http://schemas.microsoft.com/office/drawing/2014/main" id="{4468C0FD-9A66-4682-94F7-1C36BBEEABBB}"/>
              </a:ext>
            </a:extLst>
          </p:cNvPr>
          <p:cNvSpPr/>
          <p:nvPr/>
        </p:nvSpPr>
        <p:spPr>
          <a:xfrm>
            <a:off x="1265017" y="4627829"/>
            <a:ext cx="10155044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b="1" i="1" dirty="0"/>
              <a:t>Supplementary Figure 3: Absolute cell counts in the peripheral blood. </a:t>
            </a: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dirty="0">
                <a:ea typeface="Calibri" panose="020F0502020204030204" pitchFamily="34" charset="0"/>
                <a:cs typeface="Times New Roman" panose="02020603050405020304" pitchFamily="18" charset="0"/>
              </a:rPr>
              <a:t>The whole lymphocyte count was reduced in OC patients compared to the HD (p = 0.0438) (A), while there was no difference in the absolute NK cell count between OC patients and HD (p = 0.8330) (B).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91B7A2A-CCC0-4FAA-A6A0-65169251187E}"/>
              </a:ext>
            </a:extLst>
          </p:cNvPr>
          <p:cNvSpPr txBox="1"/>
          <p:nvPr/>
        </p:nvSpPr>
        <p:spPr>
          <a:xfrm>
            <a:off x="1578555" y="1193267"/>
            <a:ext cx="2747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CA2510B-B6CE-4D91-9513-CE947F566A65}"/>
              </a:ext>
            </a:extLst>
          </p:cNvPr>
          <p:cNvSpPr txBox="1"/>
          <p:nvPr/>
        </p:nvSpPr>
        <p:spPr>
          <a:xfrm>
            <a:off x="6541641" y="1193267"/>
            <a:ext cx="2747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4076578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:a16="http://schemas.microsoft.com/office/drawing/2014/main" id="{0F35EC05-D442-4758-AA52-9C746B374810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369E7F03-B0C2-4446-8E5F-80F077AAA2B2}"/>
              </a:ext>
            </a:extLst>
          </p:cNvPr>
          <p:cNvSpPr/>
          <p:nvPr/>
        </p:nvSpPr>
        <p:spPr>
          <a:xfrm>
            <a:off x="647151" y="5369560"/>
            <a:ext cx="11133723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b="1" i="1" dirty="0"/>
              <a:t>Supplementary Figure 4: </a:t>
            </a:r>
            <a:r>
              <a:rPr lang="en-GB" altLang="en-US" b="1" i="1" dirty="0">
                <a:ea typeface="Calibri" panose="020F0502020204030204" pitchFamily="34" charset="0"/>
                <a:cs typeface="Times New Roman" panose="02020603050405020304" pitchFamily="18" charset="0"/>
              </a:rPr>
              <a:t>Markers utilised to identify major cell types  </a:t>
            </a:r>
            <a:endParaRPr lang="en-GB" altLang="en-US" sz="1100" dirty="0"/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altLang="en-US" dirty="0" err="1">
                <a:ea typeface="Calibri" panose="020F0502020204030204" pitchFamily="34" charset="0"/>
                <a:cs typeface="Times New Roman" panose="02020603050405020304" pitchFamily="18" charset="0"/>
              </a:rPr>
              <a:t>Dotplot</a:t>
            </a:r>
            <a:r>
              <a:rPr lang="en-GB" altLang="en-US" dirty="0">
                <a:ea typeface="Calibri" panose="020F0502020204030204" pitchFamily="34" charset="0"/>
                <a:cs typeface="Times New Roman" panose="02020603050405020304" pitchFamily="18" charset="0"/>
              </a:rPr>
              <a:t> showing average cluster-wise expression profile of a panel of canonical high-level cell type marker genes. The size of the dots indicates the proportion of cells within the cluster that are expressing a given gene.</a:t>
            </a:r>
            <a:endParaRPr lang="en-GB" altLang="en-US" sz="3200" dirty="0"/>
          </a:p>
          <a:p>
            <a:r>
              <a:rPr lang="en-GB" dirty="0"/>
              <a:t> 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8860CC5E-F936-4860-BE2B-CD9E61AC07C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5228" y="878134"/>
            <a:ext cx="4601544" cy="43433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803746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:a16="http://schemas.microsoft.com/office/drawing/2014/main" id="{3D6975A6-B979-47EF-A27F-AAF7357E025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00300" y="25400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pic>
        <p:nvPicPr>
          <p:cNvPr id="4097" name="Picture 1039">
            <a:extLst>
              <a:ext uri="{FF2B5EF4-FFF2-40B4-BE49-F238E27FC236}">
                <a16:creationId xmlns:a16="http://schemas.microsoft.com/office/drawing/2014/main" id="{32C04D31-3513-47C0-A98B-54FB98C5279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19500" y="806893"/>
            <a:ext cx="4953000" cy="39497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3">
            <a:extLst>
              <a:ext uri="{FF2B5EF4-FFF2-40B4-BE49-F238E27FC236}">
                <a16:creationId xmlns:a16="http://schemas.microsoft.com/office/drawing/2014/main" id="{C111833F-3DFD-407A-8511-8E1B402F2562}"/>
              </a:ext>
            </a:extLst>
          </p:cNvPr>
          <p:cNvSpPr>
            <a:spLocks noChangeArrowheads="1"/>
          </p:cNvSpPr>
          <p:nvPr/>
        </p:nvSpPr>
        <p:spPr bwMode="auto">
          <a:xfrm>
            <a:off x="927055" y="4852286"/>
            <a:ext cx="10663945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b="1" i="1" dirty="0"/>
              <a:t>Supplementary Figure 5</a:t>
            </a:r>
            <a:r>
              <a:rPr kumimoji="0" lang="en-GB" altLang="en-US" b="1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: The expression of NK cell ligands on major cell types within omental tumour.</a:t>
            </a:r>
            <a:endParaRPr kumimoji="0" lang="en-GB" altLang="en-US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Cluster-wise average expression profile (heatmap) and UMI count (boxplots) of selected NK ligands of interest.   </a:t>
            </a:r>
            <a:endParaRPr kumimoji="0" lang="en-GB" altLang="en-US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311834881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3">
            <a:extLst>
              <a:ext uri="{FF2B5EF4-FFF2-40B4-BE49-F238E27FC236}">
                <a16:creationId xmlns:a16="http://schemas.microsoft.com/office/drawing/2014/main" id="{D4A84C83-F1A0-6644-F9DE-253CCE3B52F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9253" y="5679420"/>
            <a:ext cx="11953489" cy="9233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b="1" i="1" dirty="0"/>
              <a:t>Supplementary Figure 6</a:t>
            </a:r>
            <a:r>
              <a:rPr kumimoji="0" lang="en-GB" altLang="en-US" b="1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: The expression of NK cytokines across NK cell subpopulations within omental tumour.</a:t>
            </a:r>
            <a:endParaRPr kumimoji="0" lang="en-GB" altLang="en-US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en-US" dirty="0">
                <a:ea typeface="Calibri" panose="020F0502020204030204" pitchFamily="34" charset="0"/>
                <a:cs typeface="Times New Roman" panose="02020603050405020304" pitchFamily="18" charset="0"/>
              </a:rPr>
              <a:t>S</a:t>
            </a:r>
            <a:r>
              <a:rPr kumimoji="0" lang="en-GB" alt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caled average expression profile (heatmaps) of selected cytokines of interest </a:t>
            </a:r>
            <a:r>
              <a:rPr lang="en-GB" altLang="en-US" dirty="0">
                <a:ea typeface="Calibri" panose="020F0502020204030204" pitchFamily="34" charset="0"/>
                <a:cs typeface="Times New Roman" panose="02020603050405020304" pitchFamily="18" charset="0"/>
              </a:rPr>
              <a:t>across</a:t>
            </a:r>
            <a:r>
              <a:rPr kumimoji="0" lang="en-GB" alt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NK cell subpopulations identified by unsupervised clustering.   </a:t>
            </a:r>
            <a:endParaRPr kumimoji="0" lang="en-GB" altLang="en-US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pic>
        <p:nvPicPr>
          <p:cNvPr id="10" name="Picture 9" descr="A screenshot of a video game&#10;&#10;Description automatically generated">
            <a:extLst>
              <a:ext uri="{FF2B5EF4-FFF2-40B4-BE49-F238E27FC236}">
                <a16:creationId xmlns:a16="http://schemas.microsoft.com/office/drawing/2014/main" id="{8CA2C648-A776-37F2-1A1A-BF024D3E0DE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6995" r="-6483"/>
          <a:stretch/>
        </p:blipFill>
        <p:spPr>
          <a:xfrm>
            <a:off x="4884652" y="374558"/>
            <a:ext cx="2422689" cy="52037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170792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3B7EB7A-7C5F-450F-9F77-0072C93AB71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7423"/>
          <a:stretch/>
        </p:blipFill>
        <p:spPr>
          <a:xfrm>
            <a:off x="984525" y="22026"/>
            <a:ext cx="6660613" cy="6835974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B7CC7248-980B-4776-B99C-9EC99CAD682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89957" y="889843"/>
            <a:ext cx="4475978" cy="5078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b="1" i="1" dirty="0"/>
              <a:t>Supplementary Figure 7: The function, gene expression and lineage trajectory of NK cell subpopulations within omental tumour.</a:t>
            </a: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dirty="0"/>
              <a:t>UMI count (boxplots) and scaled average expression profile (heatmap) of selected receptors on NK cell subpopulations (A). </a:t>
            </a: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dirty="0"/>
              <a:t>Volcano plot (B) to demonstrate the differential gene expression profiles in the clusters with high expression of DNAM-1 (cytotoxic, activated and immature NK populations) compared to those with low DNAM-1 expression (exhausted and tissue resident NK populations). </a:t>
            </a: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dirty="0"/>
              <a:t>A </a:t>
            </a:r>
            <a:r>
              <a:rPr lang="en-GB" dirty="0" err="1"/>
              <a:t>pseudotime</a:t>
            </a:r>
            <a:r>
              <a:rPr lang="en-GB" dirty="0"/>
              <a:t> analysis (C) infers the </a:t>
            </a:r>
            <a:r>
              <a:rPr lang="en-US" altLang="en-US" dirty="0"/>
              <a:t>likely lineage trajectory of the NK cells, with the Immature NK subset as the source population. </a:t>
            </a:r>
            <a:endParaRPr lang="en-GB" b="1" i="1" dirty="0"/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endParaRPr kumimoji="0" lang="en-GB" altLang="en-US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327019337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493BD342-05C4-43E5-B87A-528825B8341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6330" y="94268"/>
            <a:ext cx="4849670" cy="6858000"/>
          </a:xfrm>
          <a:prstGeom prst="rect">
            <a:avLst/>
          </a:prstGeom>
        </p:spPr>
      </p:pic>
      <p:sp>
        <p:nvSpPr>
          <p:cNvPr id="5" name="Rectangle 3">
            <a:extLst>
              <a:ext uri="{FF2B5EF4-FFF2-40B4-BE49-F238E27FC236}">
                <a16:creationId xmlns:a16="http://schemas.microsoft.com/office/drawing/2014/main" id="{9288F3CE-AFC1-49AA-8B7B-01CFA80878A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67673" y="2189778"/>
            <a:ext cx="4141735" cy="23083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b="1" i="1" dirty="0"/>
              <a:t>Supplementary Figure 8: Communication between NK cells and other cell types within the omental tumour microenvironment.</a:t>
            </a: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dirty="0"/>
              <a:t>Interaction analysis to show the cell signaling received by the NK cells (A) and the signals sent by NK cells to other cell types (B).</a:t>
            </a:r>
            <a:endParaRPr kumimoji="0" lang="en-GB" altLang="en-US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26427029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19</TotalTime>
  <Words>514</Words>
  <Application>Microsoft Office PowerPoint</Application>
  <PresentationFormat>Widescreen</PresentationFormat>
  <Paragraphs>31</Paragraphs>
  <Slides>8</Slides>
  <Notes>3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4" baseType="lpstr">
      <vt:lpstr>Arial</vt:lpstr>
      <vt:lpstr>Calibri</vt:lpstr>
      <vt:lpstr>Calibri Light</vt:lpstr>
      <vt:lpstr>Times New Roman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anmin Zuo (Immunology and Immunotherapy)</dc:creator>
  <cp:lastModifiedBy>Rachel Pounds (Cancer and Genomic Sciences)</cp:lastModifiedBy>
  <cp:revision>43</cp:revision>
  <dcterms:created xsi:type="dcterms:W3CDTF">2023-09-28T05:34:40Z</dcterms:created>
  <dcterms:modified xsi:type="dcterms:W3CDTF">2024-10-22T20:32:14Z</dcterms:modified>
</cp:coreProperties>
</file>